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8C1D68-E11C-440A-B081-276D1AAA9A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413DFE-065F-4F92-979D-48B3997F47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0F0956-DEAA-4D35-995D-0B8F8851A9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323FDA-5245-472D-97F5-3FB35D8112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341A4-E9C9-4E24-AC75-AF0076119F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24ABD7-1EFE-4208-AB7C-2182179B38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0F6DF-8920-4BA4-8692-1B1223E77C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6CAF7-E2F3-47C5-971F-8588E8CE37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5F400E-7FFB-4C02-B00E-C4C9DF0B8D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F53BF0-DFE6-42E2-93EF-EDEB64DFE2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6429C-A484-4963-BD19-4C99E526D9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87D422-D4D5-421E-BAA5-E2B77903CC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B20FEA-58F4-49DF-B2AF-4EC780FEC1E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rcRect l="10429" t="60938" r="19432" b="9482"/>
          <a:stretch/>
        </p:blipFill>
        <p:spPr>
          <a:xfrm>
            <a:off x="1006560" y="469800"/>
            <a:ext cx="7064280" cy="2336760"/>
          </a:xfrm>
          <a:prstGeom prst="rect">
            <a:avLst/>
          </a:prstGeom>
          <a:ln w="9360">
            <a:solidFill>
              <a:srgbClr val="002060"/>
            </a:solidFill>
            <a:miter/>
          </a:ln>
          <a:effectLst>
            <a:outerShdw dist="139498" dir="2700000" blurRad="0" rotWithShape="0">
              <a:srgbClr val="333333">
                <a:alpha val="65000"/>
              </a:srgbClr>
            </a:outerShdw>
          </a:effectLst>
        </p:spPr>
      </p:pic>
      <p:grpSp>
        <p:nvGrpSpPr>
          <p:cNvPr id="42" name="Csoportba foglalás 53"/>
          <p:cNvGrpSpPr/>
          <p:nvPr/>
        </p:nvGrpSpPr>
        <p:grpSpPr>
          <a:xfrm>
            <a:off x="5054760" y="388800"/>
            <a:ext cx="134640" cy="3400560"/>
            <a:chOff x="5054760" y="388800"/>
            <a:chExt cx="134640" cy="3400560"/>
          </a:xfrm>
        </p:grpSpPr>
        <p:sp>
          <p:nvSpPr>
            <p:cNvPr id="43" name="Egyenes összekötő 17"/>
            <p:cNvSpPr/>
            <p:nvPr/>
          </p:nvSpPr>
          <p:spPr>
            <a:xfrm>
              <a:off x="5054760" y="388800"/>
              <a:ext cx="0" cy="3400560"/>
            </a:xfrm>
            <a:prstGeom prst="line">
              <a:avLst/>
            </a:prstGeom>
            <a:ln w="1908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Egyenes összekötő 18"/>
            <p:cNvSpPr/>
            <p:nvPr/>
          </p:nvSpPr>
          <p:spPr>
            <a:xfrm>
              <a:off x="5189400" y="388800"/>
              <a:ext cx="0" cy="3400560"/>
            </a:xfrm>
            <a:prstGeom prst="line">
              <a:avLst/>
            </a:prstGeom>
            <a:ln w="1908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" name="Lekerekített téglalap 13"/>
          <p:cNvSpPr/>
          <p:nvPr/>
        </p:nvSpPr>
        <p:spPr>
          <a:xfrm>
            <a:off x="6051600" y="3773520"/>
            <a:ext cx="1214280" cy="428760"/>
          </a:xfrm>
          <a:prstGeom prst="roundRect">
            <a:avLst>
              <a:gd name="adj" fmla="val 16667"/>
            </a:avLst>
          </a:prstGeom>
          <a:gradFill rotWithShape="0">
            <a:gsLst>
              <a:gs pos="0">
                <a:srgbClr val="a3c4ff"/>
              </a:gs>
              <a:gs pos="100000">
                <a:srgbClr val="e5eeff"/>
              </a:gs>
            </a:gsLst>
            <a:lin ang="16200000"/>
          </a:gradFill>
          <a:ln w="9360">
            <a:solidFill>
              <a:srgbClr val="4a7ebb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ekerekített téglalap 12"/>
          <p:cNvSpPr/>
          <p:nvPr/>
        </p:nvSpPr>
        <p:spPr>
          <a:xfrm>
            <a:off x="5653080" y="3222720"/>
            <a:ext cx="1214280" cy="428400"/>
          </a:xfrm>
          <a:prstGeom prst="roundRect">
            <a:avLst>
              <a:gd name="adj" fmla="val 16667"/>
            </a:avLst>
          </a:prstGeom>
          <a:gradFill rotWithShape="0">
            <a:gsLst>
              <a:gs pos="0">
                <a:srgbClr val="a3c4ff"/>
              </a:gs>
              <a:gs pos="100000">
                <a:srgbClr val="e5eeff"/>
              </a:gs>
            </a:gsLst>
            <a:lin ang="16200000"/>
          </a:gradFill>
          <a:ln w="9360">
            <a:solidFill>
              <a:srgbClr val="4a7ebb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églalap 6"/>
          <p:cNvSpPr/>
          <p:nvPr/>
        </p:nvSpPr>
        <p:spPr>
          <a:xfrm>
            <a:off x="5032440" y="3564000"/>
            <a:ext cx="193680" cy="28584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7"/>
          <p:cNvSpPr/>
          <p:nvPr/>
        </p:nvSpPr>
        <p:spPr>
          <a:xfrm>
            <a:off x="880920" y="3112200"/>
            <a:ext cx="7286760" cy="59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GGCAGGGTGGGCCCTGGTCCCGAGGAGGG</a:t>
            </a:r>
            <a:r>
              <a:rPr b="1" lang="hu-HU" sz="1800" spc="-1" strike="noStrike">
                <a:solidFill>
                  <a:srgbClr val="7f7f7f"/>
                </a:solidFill>
                <a:latin typeface="Courier New"/>
                <a:ea typeface="Times New Roman"/>
              </a:rPr>
              <a:t>GCAAGGTGGGTGCAGAGGGTC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7"/>
          <p:cNvSpPr/>
          <p:nvPr/>
        </p:nvSpPr>
        <p:spPr>
          <a:xfrm>
            <a:off x="4970520" y="3520440"/>
            <a:ext cx="285840" cy="32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7"/>
          <p:cNvSpPr/>
          <p:nvPr/>
        </p:nvSpPr>
        <p:spPr>
          <a:xfrm>
            <a:off x="1428840" y="3809520"/>
            <a:ext cx="6858000" cy="32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7f7f7f"/>
                </a:solidFill>
                <a:latin typeface="Courier New"/>
                <a:ea typeface="Times New Roman"/>
              </a:rPr>
              <a:t>GGCCTTTGCTGGCTTTGCAGCCAGCAT</a:t>
            </a:r>
            <a:r>
              <a:rPr b="1" lang="hu-HU" sz="18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CATCTGGTGGGTGCTGGCT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Egyenes összekötő 8"/>
          <p:cNvSpPr/>
          <p:nvPr/>
        </p:nvSpPr>
        <p:spPr>
          <a:xfrm flipH="1">
            <a:off x="5060520" y="3274920"/>
            <a:ext cx="1800" cy="285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Egyenes összekötő 9"/>
          <p:cNvSpPr/>
          <p:nvPr/>
        </p:nvSpPr>
        <p:spPr>
          <a:xfrm flipH="1">
            <a:off x="5194440" y="3841920"/>
            <a:ext cx="1440" cy="2854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Egyenes összekötő 10"/>
          <p:cNvSpPr/>
          <p:nvPr/>
        </p:nvSpPr>
        <p:spPr>
          <a:xfrm flipH="1" flipV="1">
            <a:off x="4787640" y="3284640"/>
            <a:ext cx="28548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Egyenes összekötő 11"/>
          <p:cNvSpPr/>
          <p:nvPr/>
        </p:nvSpPr>
        <p:spPr>
          <a:xfrm flipH="1" flipV="1">
            <a:off x="5182920" y="4130280"/>
            <a:ext cx="28548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églalap 14"/>
          <p:cNvSpPr/>
          <p:nvPr/>
        </p:nvSpPr>
        <p:spPr>
          <a:xfrm>
            <a:off x="962640" y="2857680"/>
            <a:ext cx="581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hu-HU" sz="1800" spc="-1" strike="noStrike">
                <a:solidFill>
                  <a:srgbClr val="000000"/>
                </a:solidFill>
                <a:latin typeface="Calibri"/>
              </a:rPr>
              <a:t>5' breakpoint in intron 2 </a:t>
            </a:r>
            <a:r>
              <a:rPr b="0" i="1" lang="hu-HU" sz="1800" spc="-1" strike="noStrike">
                <a:solidFill>
                  <a:srgbClr val="000000"/>
                </a:solidFill>
                <a:latin typeface="Calibri"/>
              </a:rPr>
              <a:t>(chr19:1,219,187-1,219,238 show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églalap 15"/>
          <p:cNvSpPr/>
          <p:nvPr/>
        </p:nvSpPr>
        <p:spPr>
          <a:xfrm>
            <a:off x="2256480" y="4159080"/>
            <a:ext cx="581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hu-HU" sz="1800" spc="-1" strike="noStrike">
                <a:solidFill>
                  <a:srgbClr val="000000"/>
                </a:solidFill>
                <a:latin typeface="Calibri"/>
              </a:rPr>
              <a:t>3' breakpoint in intron 7 </a:t>
            </a:r>
            <a:r>
              <a:rPr b="0" i="1" lang="hu-HU" sz="1800" spc="-1" strike="noStrike">
                <a:solidFill>
                  <a:srgbClr val="000000"/>
                </a:solidFill>
                <a:latin typeface="Calibri"/>
              </a:rPr>
              <a:t>(chr19:1,222,694-1,222,741 show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Szövegdoboz 16"/>
          <p:cNvSpPr/>
          <p:nvPr/>
        </p:nvSpPr>
        <p:spPr>
          <a:xfrm>
            <a:off x="214200" y="5143680"/>
            <a:ext cx="864396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400" spc="-1" strike="noStrike">
                <a:solidFill>
                  <a:srgbClr val="000000"/>
                </a:solidFill>
                <a:latin typeface="Calibri"/>
              </a:rPr>
              <a:t>Figure S4: Breakpoint sequence of the genomic deletion removing exons 3-7 of the STK11 gene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u-HU" sz="1400" spc="-1" strike="noStrike">
                <a:solidFill>
                  <a:srgbClr val="000000"/>
                </a:solidFill>
                <a:latin typeface="Calibri"/>
              </a:rPr>
              <a:t>The sequencing chromatogram produced using the sense primer is shown on top. The breakpoint is depicted using a broken line, with the additional 'A' shown in a rectangle between the two sequences. A short homologous stretch near the breakpoints is highlihted in blue. Chromosome coordinates refer to the Feb 2009 (GHCr37/hg19) human genome assembly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08T11:35:00Z</dcterms:created>
  <dc:creator>molbio</dc:creator>
  <dc:description/>
  <dc:language>en-US</dc:language>
  <cp:lastModifiedBy>molbio</cp:lastModifiedBy>
  <dcterms:modified xsi:type="dcterms:W3CDTF">2010-10-22T06:40:09Z</dcterms:modified>
  <cp:revision>22</cp:revision>
  <dc:subject/>
  <dc:title>1. dia</dc:title>
</cp:coreProperties>
</file>